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80" autoAdjust="0"/>
    <p:restoredTop sz="94660"/>
  </p:normalViewPr>
  <p:slideViewPr>
    <p:cSldViewPr>
      <p:cViewPr>
        <p:scale>
          <a:sx n="130" d="100"/>
          <a:sy n="130" d="100"/>
        </p:scale>
        <p:origin x="-294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CC9C9-812C-4C8B-A274-1C752B0A3F8A}" type="datetimeFigureOut">
              <a:rPr lang="en-US" smtClean="0"/>
              <a:pPr/>
              <a:t>2011-04-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C443A-ECFF-428C-AEFD-F34E30BFBB4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092" name="Group 252"/>
          <p:cNvGraphicFramePr>
            <a:graphicFrameLocks noGrp="1"/>
          </p:cNvGraphicFramePr>
          <p:nvPr/>
        </p:nvGraphicFramePr>
        <p:xfrm>
          <a:off x="26988" y="4991100"/>
          <a:ext cx="6858000" cy="3633789"/>
        </p:xfrm>
        <a:graphic>
          <a:graphicData uri="http://schemas.openxmlformats.org/drawingml/2006/table">
            <a:tbl>
              <a:tblPr/>
              <a:tblGrid>
                <a:gridCol w="687368"/>
                <a:gridCol w="581044"/>
                <a:gridCol w="720725"/>
                <a:gridCol w="647700"/>
                <a:gridCol w="431800"/>
                <a:gridCol w="808038"/>
                <a:gridCol w="631825"/>
                <a:gridCol w="592137"/>
                <a:gridCol w="627063"/>
                <a:gridCol w="465137"/>
                <a:gridCol w="665163"/>
              </a:tblGrid>
              <a:tr h="400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Species</a:t>
                      </a: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. sapien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norvegicu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. musculu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. </a:t>
                      </a:r>
                      <a:r>
                        <a:rPr kumimoji="0" lang="en-US" altLang="zh-TW" sz="12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crofa</a:t>
                      </a:r>
                      <a:endParaRPr kumimoji="0" lang="en-US" altLang="zh-TW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C. familiari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. cuniculu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. Gallus</a:t>
                      </a:r>
                    </a:p>
                  </a:txBody>
                  <a:tcPr marL="0" marR="0" marT="7200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R. rugulosa</a:t>
                      </a:r>
                    </a:p>
                  </a:txBody>
                  <a:tcPr marL="0" marR="0" marT="7200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X. laevi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  X. tropicalis</a:t>
                      </a:r>
                      <a:endParaRPr kumimoji="0" lang="en-US" altLang="zh-TW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. sapien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8.9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4.1</a:t>
                      </a: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16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8.9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8.9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171450" algn="l"/>
                          <a:tab pos="263525" algn="ctr"/>
                        </a:tabLst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culu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333375" algn="l"/>
                        </a:tabLst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85.2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4.1</a:t>
                      </a: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0.7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crof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4.1</a:t>
                      </a: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59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familiari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2.6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4.1</a:t>
                      </a: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uniculu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0.4</a:t>
                      </a: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7.1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7.1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7.1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. </a:t>
                      </a:r>
                      <a:r>
                        <a:rPr kumimoji="0" lang="en-US" altLang="zh-TW" sz="1400" b="1" i="1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9</a:t>
                      </a: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4.3</a:t>
                      </a: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7.9</a:t>
                      </a: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. rugulosa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4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59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laevi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96.4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43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400" b="1" i="1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. tropicalis</a:t>
                      </a:r>
                      <a:endParaRPr kumimoji="0" lang="en-US" altLang="zh-TW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TW" alt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8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0</a:t>
                      </a:r>
                      <a:endParaRPr kumimoji="0" lang="en-GB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anchorCtr="1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36026" name="Group 186"/>
          <p:cNvGraphicFramePr>
            <a:graphicFrameLocks noGrp="1"/>
          </p:cNvGraphicFramePr>
          <p:nvPr/>
        </p:nvGraphicFramePr>
        <p:xfrm>
          <a:off x="836613" y="509588"/>
          <a:ext cx="4752975" cy="3931920"/>
        </p:xfrm>
        <a:graphic>
          <a:graphicData uri="http://schemas.openxmlformats.org/drawingml/2006/table">
            <a:tbl>
              <a:tblPr/>
              <a:tblGrid>
                <a:gridCol w="1335087"/>
                <a:gridCol w="250825"/>
                <a:gridCol w="3167063"/>
              </a:tblGrid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984250" algn="ctr"/>
                          <a:tab pos="1533525" algn="l"/>
                        </a:tabLst>
                      </a:pPr>
                      <a:r>
                        <a:rPr kumimoji="0" lang="en-US" altLang="zh-TW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pecies	</a:t>
                      </a:r>
                      <a:endParaRPr kumimoji="0" lang="en-US" altLang="zh-TW" sz="2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ecretin amino acid sequences</a:t>
                      </a:r>
                      <a:endParaRPr kumimoji="0" lang="en-US" altLang="zh-TW" sz="2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</a:tr>
              <a:tr h="195263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85775" algn="l"/>
                        </a:tabLst>
                      </a:pPr>
                      <a:r>
                        <a:rPr kumimoji="0" lang="en-US" altLang="zh-HK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</a:rPr>
                        <a:t>1      5       10      15       20      2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22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. sapiens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85775" algn="l"/>
                        </a:tabLst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REG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03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. norvegicus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D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M. musculus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M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D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B. taurus </a:t>
                      </a:r>
                      <a:r>
                        <a:rPr kumimoji="0" lang="en-US" altLang="zh-HK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RD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C. familiaris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RE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O. cuniculus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571500" algn="l"/>
                        </a:tabLst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RDR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L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. scrofa</a:t>
                      </a:r>
                      <a:r>
                        <a:rPr kumimoji="0" lang="en-US" altLang="zh-HK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RD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LQRLLQGLV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G. gallus</a:t>
                      </a:r>
                      <a:r>
                        <a:rPr kumimoji="0" lang="en-US" altLang="zh-HK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 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47675" algn="l"/>
                        </a:tabLst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L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Y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KMRGN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QVQKFIQNLM-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. rugulosa </a:t>
                      </a:r>
                      <a:r>
                        <a:rPr kumimoji="0" lang="en-US" altLang="zh-HK" sz="1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  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47675" algn="l"/>
                        </a:tabLst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V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M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ARG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IRKIINSALA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X. laevis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47675" algn="l"/>
                        </a:tabLst>
                      </a:pP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V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F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ARGS</a:t>
                      </a:r>
                      <a:r>
                        <a:rPr kumimoji="0" lang="en-US" altLang="zh-HK" sz="2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IRKIINSALA</a:t>
                      </a:r>
                      <a:endParaRPr kumimoji="0" lang="en-US" altLang="zh-HK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HK" sz="1800" b="0" i="1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X. tropicalis</a:t>
                      </a:r>
                      <a:endParaRPr kumimoji="0" lang="en-US" altLang="zh-HK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>
                          <a:tab pos="447675" algn="l"/>
                        </a:tabLst>
                      </a:pPr>
                      <a:r>
                        <a:rPr kumimoji="0" lang="en-US" altLang="zh-HK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H</a:t>
                      </a:r>
                      <a:r>
                        <a:rPr kumimoji="0" lang="en-US" altLang="zh-HK" sz="2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V</a:t>
                      </a:r>
                      <a:r>
                        <a:rPr kumimoji="0" lang="en-US" altLang="zh-HK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DG</a:t>
                      </a:r>
                      <a:r>
                        <a:rPr kumimoji="0" lang="en-US" altLang="zh-HK" sz="2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MF</a:t>
                      </a:r>
                      <a:r>
                        <a:rPr kumimoji="0" lang="en-US" altLang="zh-HK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TSE</a:t>
                      </a:r>
                      <a:r>
                        <a:rPr kumimoji="0" lang="en-US" altLang="zh-HK" sz="2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F</a:t>
                      </a:r>
                      <a:r>
                        <a:rPr kumimoji="0" lang="en-US" altLang="zh-HK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S</a:t>
                      </a:r>
                      <a:r>
                        <a:rPr kumimoji="0" lang="en-US" altLang="zh-HK" sz="2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RARGS</a:t>
                      </a:r>
                      <a:r>
                        <a:rPr kumimoji="0" lang="en-US" altLang="zh-HK" sz="2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</a:t>
                      </a:r>
                      <a:r>
                        <a:rPr kumimoji="0" lang="en-US" altLang="zh-HK" sz="2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新細明體" pitchFamily="18" charset="-120"/>
                          <a:cs typeface="Courier New" pitchFamily="49" charset="0"/>
                        </a:rPr>
                        <a:t>AIRKIINSALA</a:t>
                      </a:r>
                      <a:endParaRPr kumimoji="0" lang="en-US" altLang="zh-HK" sz="2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新細明體" pitchFamily="18" charset="-120"/>
                        <a:cs typeface="Courier New" pitchFamily="49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400" name="Text Box 4"/>
          <p:cNvSpPr txBox="1">
            <a:spLocks noChangeArrowheads="1"/>
          </p:cNvSpPr>
          <p:nvPr/>
        </p:nvSpPr>
        <p:spPr bwMode="auto">
          <a:xfrm>
            <a:off x="571500" y="309563"/>
            <a:ext cx="29845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200" b="1">
                <a:ea typeface="新細明體" pitchFamily="18" charset="-120"/>
              </a:rPr>
              <a:t>A</a:t>
            </a:r>
          </a:p>
        </p:txBody>
      </p:sp>
      <p:sp>
        <p:nvSpPr>
          <p:cNvPr id="10401" name="Text Box 4"/>
          <p:cNvSpPr txBox="1">
            <a:spLocks noChangeArrowheads="1"/>
          </p:cNvSpPr>
          <p:nvPr/>
        </p:nvSpPr>
        <p:spPr bwMode="auto">
          <a:xfrm>
            <a:off x="0" y="4678363"/>
            <a:ext cx="29845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200" b="1">
                <a:ea typeface="新細明體" pitchFamily="18" charset="-120"/>
              </a:rPr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77</Words>
  <Application>Microsoft Office PowerPoint</Application>
  <PresentationFormat>A4 Paper (210x297 mm)</PresentationFormat>
  <Paragraphs>10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3</cp:revision>
  <dcterms:created xsi:type="dcterms:W3CDTF">2011-04-07T14:20:31Z</dcterms:created>
  <dcterms:modified xsi:type="dcterms:W3CDTF">2011-04-09T13:49:05Z</dcterms:modified>
</cp:coreProperties>
</file>